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58" y="1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B7D34C-863A-44BF-98C9-4181B87D000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36A3246-4B33-4214-8C7D-A40B15E510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E7DFC2-A109-41C5-9E04-E73CDD1FDC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39C10-B151-452B-802E-4F2408C87350}" type="datetimeFigureOut">
              <a:rPr lang="en-US" smtClean="0"/>
              <a:t>5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E597AC-6F39-48CA-A864-D7C8A125B4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AF833E-240E-404E-8DF2-E1B16CD027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9EA42-5E92-431F-B034-48B5A556F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2010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891004-5881-422C-ABBC-A64BE475C8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D6E3CF-161E-4BD9-A228-E76B83A83C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A93771-B47C-4926-9274-B6D42A32D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39C10-B151-452B-802E-4F2408C87350}" type="datetimeFigureOut">
              <a:rPr lang="en-US" smtClean="0"/>
              <a:t>5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5B528B-7296-497A-A3CC-9B95D01D77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A57089-1F4F-439A-A4A3-6CA39C62DD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9EA42-5E92-431F-B034-48B5A556F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824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040D025-4819-4459-881E-7CDB1405C32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391E18-11C4-4E20-B04C-426D0C3B1A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E254F9-1F65-4440-B007-2DAF594274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39C10-B151-452B-802E-4F2408C87350}" type="datetimeFigureOut">
              <a:rPr lang="en-US" smtClean="0"/>
              <a:t>5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2247DF-A06C-4813-AD01-80103A8BB7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FA405E-9E89-4761-BBED-4BA39083F4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9EA42-5E92-431F-B034-48B5A556F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7248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9F87DA-37E8-4977-AB5B-9E6E032FE7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50C528-25C2-4D4D-AC98-F618847C79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B40578-9BF5-4447-87F6-8F1A8954F1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39C10-B151-452B-802E-4F2408C87350}" type="datetimeFigureOut">
              <a:rPr lang="en-US" smtClean="0"/>
              <a:t>5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C31E76-E15B-4D21-8A91-0A6E494529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802F2C-30EA-463B-A1DC-5C5E35E41D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9EA42-5E92-431F-B034-48B5A556F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3610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E5D88C-2DE0-4FA9-B3CC-3E2D3EF750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B46346-2FDD-4C74-9ACD-3734CD4BFF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56C2D2-0D3A-40CF-A960-6E02148D91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39C10-B151-452B-802E-4F2408C87350}" type="datetimeFigureOut">
              <a:rPr lang="en-US" smtClean="0"/>
              <a:t>5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79D133-28A6-41E5-98B8-9DA3F0197E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ED39C8-3CBB-4E10-BC90-D465775DB3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9EA42-5E92-431F-B034-48B5A556F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5733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F1A4CB-85EF-406A-91A7-E24BA19E49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460B72-05FB-409F-8150-E2C86D9B01A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EE73C7-4805-4BD9-A446-3AED450AB5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6CA95E-5B93-4167-A80D-D839516AF9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39C10-B151-452B-802E-4F2408C87350}" type="datetimeFigureOut">
              <a:rPr lang="en-US" smtClean="0"/>
              <a:t>5/2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96B5AB-FFBE-4BAC-90D5-EC565663D2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64C6D6-E088-40AE-AB2B-A9958B4E55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9EA42-5E92-431F-B034-48B5A556F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7116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BCF302-FBA0-4B07-9253-64C24B1ABE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0214E7-3E41-4212-AE40-1B4AB8832D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2E42E4F-9C7A-42B8-864D-054EF9C226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EEB5640-5ACB-4061-96E2-E61AC225AD9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CECEAB9-E943-4927-ADCC-3C83C869212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F9F9421-B9F8-4EAB-B6CE-3F6DBCDCCF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39C10-B151-452B-802E-4F2408C87350}" type="datetimeFigureOut">
              <a:rPr lang="en-US" smtClean="0"/>
              <a:t>5/28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59F2BA5-D511-4CD4-99BF-94E794AF04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7DEA9A8-8FBC-4C99-8807-9E8B98423A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9EA42-5E92-431F-B034-48B5A556F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8151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EDD7BE-920D-4E8C-98DB-28116BE64E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276F864-C7C9-4723-8F17-6F99A10EE0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39C10-B151-452B-802E-4F2408C87350}" type="datetimeFigureOut">
              <a:rPr lang="en-US" smtClean="0"/>
              <a:t>5/28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77EC03B-67FD-4E82-B350-54F43D16DF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46D1053-3EC5-4BC7-9A8D-C507E22CC2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9EA42-5E92-431F-B034-48B5A556F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1681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9F901EA-38F5-40C9-B369-6069F5E3B5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39C10-B151-452B-802E-4F2408C87350}" type="datetimeFigureOut">
              <a:rPr lang="en-US" smtClean="0"/>
              <a:t>5/28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C60FCC2-CEC1-40F1-A475-30FBD115B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90BA15B-68E7-4732-9CA5-64EBFEB5BB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9EA42-5E92-431F-B034-48B5A556F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099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E69000-E3ED-43D5-A6B0-49B75AAE1F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4D43F4-DFE3-446E-8E8C-18A9D58EA2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4DF61E-751F-4AA2-A0E2-92663332FB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904917-AF8E-456A-8EA2-19266FC5E9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39C10-B151-452B-802E-4F2408C87350}" type="datetimeFigureOut">
              <a:rPr lang="en-US" smtClean="0"/>
              <a:t>5/2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2FFDC7-69A7-44C1-AE6C-5B8B294C91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45195DF-91D2-41C5-ADB2-12B0BE9C97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9EA42-5E92-431F-B034-48B5A556F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1757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9C4464-1A29-4689-9261-9AE7B01E12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69D394-5DD7-4880-B331-590CDB66BC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AD40C2A-E263-415A-8733-F5D239645C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8A0AFE-AC5C-46B1-9CD8-A706A4E19C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39C10-B151-452B-802E-4F2408C87350}" type="datetimeFigureOut">
              <a:rPr lang="en-US" smtClean="0"/>
              <a:t>5/2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D92267-5891-4C79-87A9-A106427886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4AA5A03-4B7B-4189-AFE7-36F39A8D34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9EA42-5E92-431F-B034-48B5A556F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3736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F2602C1-DC6A-4F83-9CAA-80B522EB22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586FA8-1316-4004-A210-C5D48DD36D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B54F40-2218-495F-BEE3-9309979B7BC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D39C10-B151-452B-802E-4F2408C87350}" type="datetimeFigureOut">
              <a:rPr lang="en-US" smtClean="0"/>
              <a:t>5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59CA73-1099-46B6-B7D0-736A41E548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9696E5-24DC-4C3D-96FA-88429DD8F2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E9EA42-5E92-431F-B034-48B5A556F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498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64FE74D-03F3-41DB-9B00-4291FA127C3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01556460"/>
              </p:ext>
            </p:extLst>
          </p:nvPr>
        </p:nvGraphicFramePr>
        <p:xfrm>
          <a:off x="3103101" y="1892534"/>
          <a:ext cx="5736771" cy="2714838"/>
        </p:xfrm>
        <a:graphic>
          <a:graphicData uri="http://schemas.openxmlformats.org/drawingml/2006/table">
            <a:tbl>
              <a:tblPr firstRow="1" bandRow="1">
                <a:tableStyleId>{F2DE63D5-997A-4646-A377-4702673A728D}</a:tableStyleId>
              </a:tblPr>
              <a:tblGrid>
                <a:gridCol w="2795595">
                  <a:extLst>
                    <a:ext uri="{9D8B030D-6E8A-4147-A177-3AD203B41FA5}">
                      <a16:colId xmlns:a16="http://schemas.microsoft.com/office/drawing/2014/main" val="3551576739"/>
                    </a:ext>
                  </a:extLst>
                </a:gridCol>
                <a:gridCol w="903515">
                  <a:extLst>
                    <a:ext uri="{9D8B030D-6E8A-4147-A177-3AD203B41FA5}">
                      <a16:colId xmlns:a16="http://schemas.microsoft.com/office/drawing/2014/main" val="1953313544"/>
                    </a:ext>
                  </a:extLst>
                </a:gridCol>
                <a:gridCol w="921875">
                  <a:extLst>
                    <a:ext uri="{9D8B030D-6E8A-4147-A177-3AD203B41FA5}">
                      <a16:colId xmlns:a16="http://schemas.microsoft.com/office/drawing/2014/main" val="1401498285"/>
                    </a:ext>
                  </a:extLst>
                </a:gridCol>
                <a:gridCol w="1115786">
                  <a:extLst>
                    <a:ext uri="{9D8B030D-6E8A-4147-A177-3AD203B41FA5}">
                      <a16:colId xmlns:a16="http://schemas.microsoft.com/office/drawing/2014/main" val="766009233"/>
                    </a:ext>
                  </a:extLst>
                </a:gridCol>
              </a:tblGrid>
              <a:tr h="680439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/>
                        <a:t>Environmental parameter</a:t>
                      </a:r>
                      <a:endParaRPr lang="en-US" sz="1200" b="0" kern="1200" dirty="0">
                        <a:solidFill>
                          <a:schemeClr val="tx1"/>
                        </a:solidFill>
                        <a:latin typeface="Helvetica"/>
                        <a:ea typeface="+mn-ea"/>
                        <a:cs typeface="Helvetica"/>
                      </a:endParaRPr>
                    </a:p>
                  </a:txBody>
                  <a:tcPr marL="84220" marR="84220" marT="50953" marB="50953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/>
                        <a:t>Effect on C chain length- North </a:t>
                      </a:r>
                      <a:endParaRPr lang="en-US" sz="1200" b="0" kern="1200" dirty="0">
                        <a:solidFill>
                          <a:schemeClr val="tx1"/>
                        </a:solidFill>
                        <a:latin typeface="Helvetica"/>
                        <a:ea typeface="+mn-ea"/>
                        <a:cs typeface="Helvetica"/>
                      </a:endParaRPr>
                    </a:p>
                  </a:txBody>
                  <a:tcPr marL="84220" marR="84220" marT="50953" marB="50953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/>
                        <a:t>Effect on C chain length- South</a:t>
                      </a:r>
                      <a:endParaRPr lang="en-US" sz="1200" b="0" kern="1200" dirty="0">
                        <a:solidFill>
                          <a:schemeClr val="tx1"/>
                        </a:solidFill>
                        <a:latin typeface="Helvetica"/>
                        <a:ea typeface="+mn-ea"/>
                        <a:cs typeface="Helvetica"/>
                      </a:endParaRPr>
                    </a:p>
                  </a:txBody>
                  <a:tcPr marL="84220" marR="84220" marT="50953" marB="50953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/>
                        <a:t>Interaction with Geography</a:t>
                      </a:r>
                      <a:endParaRPr lang="en-US" sz="1200" b="0" kern="1200" dirty="0">
                        <a:solidFill>
                          <a:schemeClr val="tx1"/>
                        </a:solidFill>
                        <a:latin typeface="Helvetica"/>
                        <a:ea typeface="+mn-ea"/>
                        <a:cs typeface="Helvetica"/>
                      </a:endParaRPr>
                    </a:p>
                  </a:txBody>
                  <a:tcPr marL="84220" marR="84220" marT="50953" marB="50953"/>
                </a:tc>
                <a:extLst>
                  <a:ext uri="{0D108BD9-81ED-4DB2-BD59-A6C34878D82A}">
                    <a16:rowId xmlns:a16="http://schemas.microsoft.com/office/drawing/2014/main" val="2107647192"/>
                  </a:ext>
                </a:extLst>
              </a:tr>
              <a:tr h="29787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/>
                        <a:t>Genomic Group</a:t>
                      </a:r>
                      <a:endParaRPr lang="en-US" sz="1200" b="0" kern="1200" dirty="0">
                        <a:solidFill>
                          <a:schemeClr val="tx1"/>
                        </a:solidFill>
                        <a:latin typeface="Helvetica"/>
                        <a:ea typeface="+mn-ea"/>
                        <a:cs typeface="Helvetica"/>
                      </a:endParaRPr>
                    </a:p>
                  </a:txBody>
                  <a:tcPr marL="84220" marR="84220" marT="50953" marB="50953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</a:p>
                  </a:txBody>
                  <a:tcPr marL="84220" marR="84220" marT="50953" marB="50953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</a:p>
                  </a:txBody>
                  <a:tcPr marL="84220" marR="84220" marT="50953" marB="50953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</a:p>
                  </a:txBody>
                  <a:tcPr marL="84220" marR="84220" marT="50953" marB="50953"/>
                </a:tc>
                <a:extLst>
                  <a:ext uri="{0D108BD9-81ED-4DB2-BD59-A6C34878D82A}">
                    <a16:rowId xmlns:a16="http://schemas.microsoft.com/office/drawing/2014/main" val="3042887569"/>
                  </a:ext>
                </a:extLst>
              </a:tr>
              <a:tr h="31670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/>
                        <a:t>Max temperature of warmest month</a:t>
                      </a:r>
                      <a:endParaRPr lang="en-US" sz="1200" b="0" kern="1200" dirty="0">
                        <a:solidFill>
                          <a:schemeClr val="tx1"/>
                        </a:solidFill>
                        <a:latin typeface="Helvetica"/>
                        <a:ea typeface="+mn-ea"/>
                        <a:cs typeface="Helvetica"/>
                      </a:endParaRPr>
                    </a:p>
                  </a:txBody>
                  <a:tcPr marL="84220" marR="84220" marT="50953" marB="50953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0007</a:t>
                      </a:r>
                    </a:p>
                  </a:txBody>
                  <a:tcPr marL="84220" marR="84220" marT="50953" marB="50953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</a:p>
                  </a:txBody>
                  <a:tcPr marL="84220" marR="84220" marT="50953" marB="50953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71319</a:t>
                      </a:r>
                    </a:p>
                  </a:txBody>
                  <a:tcPr marL="84220" marR="84220" marT="50953" marB="50953"/>
                </a:tc>
                <a:extLst>
                  <a:ext uri="{0D108BD9-81ED-4DB2-BD59-A6C34878D82A}">
                    <a16:rowId xmlns:a16="http://schemas.microsoft.com/office/drawing/2014/main" val="3003658868"/>
                  </a:ext>
                </a:extLst>
              </a:tr>
              <a:tr h="31670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/>
                        <a:t>Min temperature of coldest month</a:t>
                      </a:r>
                      <a:endParaRPr lang="en-US" sz="1200" b="0" kern="1200" dirty="0">
                        <a:solidFill>
                          <a:schemeClr val="tx1"/>
                        </a:solidFill>
                        <a:latin typeface="Helvetica"/>
                        <a:ea typeface="+mn-ea"/>
                        <a:cs typeface="Helvetica"/>
                      </a:endParaRPr>
                    </a:p>
                  </a:txBody>
                  <a:tcPr marL="84220" marR="84220" marT="50953" marB="50953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3070</a:t>
                      </a:r>
                    </a:p>
                  </a:txBody>
                  <a:tcPr marL="84220" marR="84220" marT="50953" marB="50953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</a:p>
                  </a:txBody>
                  <a:tcPr marL="84220" marR="84220" marT="50953" marB="50953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</a:p>
                  </a:txBody>
                  <a:tcPr marL="84220" marR="84220" marT="50953" marB="50953"/>
                </a:tc>
                <a:extLst>
                  <a:ext uri="{0D108BD9-81ED-4DB2-BD59-A6C34878D82A}">
                    <a16:rowId xmlns:a16="http://schemas.microsoft.com/office/drawing/2014/main" val="646450743"/>
                  </a:ext>
                </a:extLst>
              </a:tr>
              <a:tr h="31670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/>
                        <a:t>Precipitation of wettest month</a:t>
                      </a:r>
                      <a:endParaRPr lang="en-US" sz="1200" b="0" kern="1200" dirty="0">
                        <a:solidFill>
                          <a:schemeClr val="tx1"/>
                        </a:solidFill>
                        <a:latin typeface="Helvetica"/>
                        <a:ea typeface="+mn-ea"/>
                        <a:cs typeface="Helvetica"/>
                      </a:endParaRPr>
                    </a:p>
                  </a:txBody>
                  <a:tcPr marL="84220" marR="84220" marT="50953" marB="50953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9460</a:t>
                      </a:r>
                    </a:p>
                  </a:txBody>
                  <a:tcPr marL="84220" marR="84220" marT="50953" marB="50953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0012</a:t>
                      </a:r>
                    </a:p>
                  </a:txBody>
                  <a:tcPr marL="84220" marR="84220" marT="50953" marB="50953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0011</a:t>
                      </a:r>
                    </a:p>
                  </a:txBody>
                  <a:tcPr marL="84220" marR="84220" marT="50953" marB="50953"/>
                </a:tc>
                <a:extLst>
                  <a:ext uri="{0D108BD9-81ED-4DB2-BD59-A6C34878D82A}">
                    <a16:rowId xmlns:a16="http://schemas.microsoft.com/office/drawing/2014/main" val="2826670759"/>
                  </a:ext>
                </a:extLst>
              </a:tr>
              <a:tr h="31670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/>
                        <a:t>Precipitation of driest month</a:t>
                      </a:r>
                      <a:endParaRPr lang="en-US" sz="1200" b="0" kern="1200" dirty="0">
                        <a:solidFill>
                          <a:schemeClr val="tx1"/>
                        </a:solidFill>
                        <a:latin typeface="Helvetica"/>
                        <a:ea typeface="+mn-ea"/>
                        <a:cs typeface="Helvetica"/>
                      </a:endParaRPr>
                    </a:p>
                  </a:txBody>
                  <a:tcPr marL="84220" marR="84220" marT="50953" marB="50953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0782</a:t>
                      </a:r>
                    </a:p>
                  </a:txBody>
                  <a:tcPr marL="84220" marR="84220" marT="50953" marB="50953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6783</a:t>
                      </a:r>
                    </a:p>
                  </a:txBody>
                  <a:tcPr marL="84220" marR="84220" marT="50953" marB="50953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8711</a:t>
                      </a:r>
                    </a:p>
                  </a:txBody>
                  <a:tcPr marL="84220" marR="84220" marT="50953" marB="50953"/>
                </a:tc>
                <a:extLst>
                  <a:ext uri="{0D108BD9-81ED-4DB2-BD59-A6C34878D82A}">
                    <a16:rowId xmlns:a16="http://schemas.microsoft.com/office/drawing/2014/main" val="3483597049"/>
                  </a:ext>
                </a:extLst>
              </a:tr>
              <a:tr h="316708"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200" kern="1200" dirty="0"/>
                        <a:t>Distance to the coast</a:t>
                      </a:r>
                      <a:endParaRPr lang="en-US" sz="1200" b="0" kern="1200" dirty="0">
                        <a:solidFill>
                          <a:schemeClr val="tx1"/>
                        </a:solidFill>
                        <a:latin typeface="Helvetica"/>
                        <a:ea typeface="+mn-ea"/>
                        <a:cs typeface="Helvetica"/>
                      </a:endParaRPr>
                    </a:p>
                  </a:txBody>
                  <a:tcPr marL="84220" marR="84220" marT="50953" marB="50953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5262</a:t>
                      </a:r>
                    </a:p>
                  </a:txBody>
                  <a:tcPr marL="84220" marR="84220" marT="50953" marB="50953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0022</a:t>
                      </a:r>
                    </a:p>
                  </a:txBody>
                  <a:tcPr marL="84220" marR="84220" marT="50953" marB="50953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0017</a:t>
                      </a:r>
                    </a:p>
                  </a:txBody>
                  <a:tcPr marL="84220" marR="84220" marT="50953" marB="50953"/>
                </a:tc>
                <a:extLst>
                  <a:ext uri="{0D108BD9-81ED-4DB2-BD59-A6C34878D82A}">
                    <a16:rowId xmlns:a16="http://schemas.microsoft.com/office/drawing/2014/main" val="207478425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247089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5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la Katz</dc:creator>
  <cp:lastModifiedBy>Ella Katz</cp:lastModifiedBy>
  <cp:revision>1</cp:revision>
  <dcterms:created xsi:type="dcterms:W3CDTF">2021-05-28T15:18:02Z</dcterms:created>
  <dcterms:modified xsi:type="dcterms:W3CDTF">2021-05-28T15:18:33Z</dcterms:modified>
</cp:coreProperties>
</file>